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13716000" cy="11430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180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la, Christopher A" userId="3744e99d-2923-4ad2-9f75-6fa40f6eef64" providerId="ADAL" clId="{7D3CE60F-A838-4F68-8C0C-B0377E408CBF}"/>
    <pc:docChg chg="modSld">
      <pc:chgData name="Mela, Christopher A" userId="3744e99d-2923-4ad2-9f75-6fa40f6eef64" providerId="ADAL" clId="{7D3CE60F-A838-4F68-8C0C-B0377E408CBF}" dt="2021-04-11T19:19:51.930" v="20" actId="20577"/>
      <pc:docMkLst>
        <pc:docMk/>
      </pc:docMkLst>
      <pc:sldChg chg="modSp mod">
        <pc:chgData name="Mela, Christopher A" userId="3744e99d-2923-4ad2-9f75-6fa40f6eef64" providerId="ADAL" clId="{7D3CE60F-A838-4F68-8C0C-B0377E408CBF}" dt="2021-04-11T19:19:51.930" v="20" actId="20577"/>
        <pc:sldMkLst>
          <pc:docMk/>
          <pc:sldMk cId="3953601856" sldId="257"/>
        </pc:sldMkLst>
        <pc:spChg chg="mod">
          <ac:chgData name="Mela, Christopher A" userId="3744e99d-2923-4ad2-9f75-6fa40f6eef64" providerId="ADAL" clId="{7D3CE60F-A838-4F68-8C0C-B0377E408CBF}" dt="2021-04-11T19:19:51.930" v="20" actId="20577"/>
          <ac:spMkLst>
            <pc:docMk/>
            <pc:sldMk cId="3953601856" sldId="257"/>
            <ac:spMk id="3" creationId="{F0A8562B-65EA-46F7-9812-6FEBA8FC309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1870605"/>
            <a:ext cx="11658600" cy="3979333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6003397"/>
            <a:ext cx="10287000" cy="2759603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863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412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608542"/>
            <a:ext cx="2957513" cy="968639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608542"/>
            <a:ext cx="8701088" cy="968639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510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137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2849566"/>
            <a:ext cx="11830050" cy="4754562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7649107"/>
            <a:ext cx="11830050" cy="2500312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/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945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3042708"/>
            <a:ext cx="5829300" cy="72522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3042708"/>
            <a:ext cx="5829300" cy="72522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043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608544"/>
            <a:ext cx="11830050" cy="22092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2801938"/>
            <a:ext cx="5802510" cy="1373187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4175125"/>
            <a:ext cx="5802510" cy="61409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2801938"/>
            <a:ext cx="5831087" cy="1373187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4175125"/>
            <a:ext cx="5831087" cy="61409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358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323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543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62000"/>
            <a:ext cx="4423767" cy="26670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1645711"/>
            <a:ext cx="6943725" cy="8122708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429000"/>
            <a:ext cx="4423767" cy="6352647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635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62000"/>
            <a:ext cx="4423767" cy="26670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1645711"/>
            <a:ext cx="6943725" cy="8122708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429000"/>
            <a:ext cx="4423767" cy="6352647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77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608544"/>
            <a:ext cx="11830050" cy="22092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3042708"/>
            <a:ext cx="11830050" cy="72522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0593919"/>
            <a:ext cx="3086100" cy="6085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690AC-249F-46DC-A412-390B1E5441BE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0593919"/>
            <a:ext cx="4629150" cy="6085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0593919"/>
            <a:ext cx="3086100" cy="6085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F4F6C-AAFF-486F-8629-3033A87F5E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191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D0FCA19-E76D-4538-929A-EF4D6E1C9C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1600" y="2887681"/>
            <a:ext cx="10972800" cy="427987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0A8562B-65EA-46F7-9812-6FEBA8FC309D}"/>
              </a:ext>
            </a:extLst>
          </p:cNvPr>
          <p:cNvSpPr/>
          <p:nvPr/>
        </p:nvSpPr>
        <p:spPr>
          <a:xfrm>
            <a:off x="1371600" y="7167551"/>
            <a:ext cx="109728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st accuracy versus number of images in the training set.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Training set size had a distinct effect on test accuracy when conducting training for each of the three networks on the colon tissue dataset (A) and the cell line A dataset (discrete nuclear texture) (B).  All networks demonstrate a general improvement in accuracy with number of images, with exceptions.  In the tissue set, the Mask R-CNN test accuracy fluctuated, although the largest training set still provided the best accuracy.  When training the cell line dataset, it was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rDis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at fluctuated, while Mask R-CNN performed best when trained on 60 images rather than the maximum number.</a:t>
            </a:r>
            <a:endParaRPr lang="en-US" sz="16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3601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D5096B1AD2CCF4FAB0BA4D16B864C84" ma:contentTypeVersion="8" ma:contentTypeDescription="Create a new document." ma:contentTypeScope="" ma:versionID="3e6634e1a46f01af2a4bae30cea8a8d1">
  <xsd:schema xmlns:xsd="http://www.w3.org/2001/XMLSchema" xmlns:xs="http://www.w3.org/2001/XMLSchema" xmlns:p="http://schemas.microsoft.com/office/2006/metadata/properties" xmlns:ns3="4c68db64-2c3b-44bc-a459-26fe4a080329" targetNamespace="http://schemas.microsoft.com/office/2006/metadata/properties" ma:root="true" ma:fieldsID="54f823baa49fc3dd204a54c49a4451f3" ns3:_="">
    <xsd:import namespace="4c68db64-2c3b-44bc-a459-26fe4a0803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68db64-2c3b-44bc-a459-26fe4a0803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CF82831-59BE-490C-9949-D324648CE3B3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0D45EFDD-0827-49AF-B0C6-C2844341D56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7EF4BE1-9C0F-438C-8D0D-70C2D17DFEB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c68db64-2c3b-44bc-a459-26fe4a0803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24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a, Christopher A</dc:creator>
  <cp:lastModifiedBy>Mela, Christopher A</cp:lastModifiedBy>
  <cp:revision>1</cp:revision>
  <dcterms:created xsi:type="dcterms:W3CDTF">2021-01-03T16:02:32Z</dcterms:created>
  <dcterms:modified xsi:type="dcterms:W3CDTF">2021-04-11T19:19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5096B1AD2CCF4FAB0BA4D16B864C84</vt:lpwstr>
  </property>
</Properties>
</file>